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1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636"/>
    <p:restoredTop sz="96466"/>
  </p:normalViewPr>
  <p:slideViewPr>
    <p:cSldViewPr snapToGrid="0" snapToObjects="1">
      <p:cViewPr varScale="1">
        <p:scale>
          <a:sx n="160" d="100"/>
          <a:sy n="160" d="100"/>
        </p:scale>
        <p:origin x="168" y="3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79B74B-81DA-1E4A-8C6E-C54F5106C642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70C003-AECD-FB43-B893-604E3282AC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973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9517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296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118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58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733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887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966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98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44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643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427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F4C1D-752B-0446-887A-95107A1AF4AC}" type="datetimeFigureOut">
              <a:rPr kumimoji="1" lang="ja-JP" altLang="en-US" smtClean="0"/>
              <a:t>2021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DE9D2-30DE-7941-9635-844B2F4CF4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60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6057939-40BC-DA4B-9CAE-73464E705100}"/>
              </a:ext>
            </a:extLst>
          </p:cNvPr>
          <p:cNvSpPr txBox="1"/>
          <p:nvPr/>
        </p:nvSpPr>
        <p:spPr>
          <a:xfrm>
            <a:off x="1143710" y="1753840"/>
            <a:ext cx="4495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4 Table. Primers and TaqMan probes used for real-time PCR.</a:t>
            </a:r>
            <a:endParaRPr lang="ja-JP" altLang="ja-JP" sz="1200"/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FF722B0A-1D67-0744-B00A-E4532260D1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3570791"/>
              </p:ext>
            </p:extLst>
          </p:nvPr>
        </p:nvGraphicFramePr>
        <p:xfrm>
          <a:off x="1075131" y="2126826"/>
          <a:ext cx="7184951" cy="202607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8469">
                  <a:extLst>
                    <a:ext uri="{9D8B030D-6E8A-4147-A177-3AD203B41FA5}">
                      <a16:colId xmlns:a16="http://schemas.microsoft.com/office/drawing/2014/main" val="2227698734"/>
                    </a:ext>
                  </a:extLst>
                </a:gridCol>
                <a:gridCol w="1866900">
                  <a:extLst>
                    <a:ext uri="{9D8B030D-6E8A-4147-A177-3AD203B41FA5}">
                      <a16:colId xmlns:a16="http://schemas.microsoft.com/office/drawing/2014/main" val="1508856502"/>
                    </a:ext>
                  </a:extLst>
                </a:gridCol>
                <a:gridCol w="1775460">
                  <a:extLst>
                    <a:ext uri="{9D8B030D-6E8A-4147-A177-3AD203B41FA5}">
                      <a16:colId xmlns:a16="http://schemas.microsoft.com/office/drawing/2014/main" val="232967609"/>
                    </a:ext>
                  </a:extLst>
                </a:gridCol>
                <a:gridCol w="2484122">
                  <a:extLst>
                    <a:ext uri="{9D8B030D-6E8A-4147-A177-3AD203B41FA5}">
                      <a16:colId xmlns:a16="http://schemas.microsoft.com/office/drawing/2014/main" val="1057909607"/>
                    </a:ext>
                  </a:extLst>
                </a:gridCol>
              </a:tblGrid>
              <a:tr h="2864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Gene</a:t>
                      </a:r>
                      <a:endParaRPr kumimoji="1" lang="ja-JP" altLang="en-US" sz="1000">
                        <a:latin typeface="+mn-lt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Forward primer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Reverse primer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Probe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3456750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1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CACGTCATGCTGGTTGC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ACGTACGCCGGCTGCT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CTTCTTCTTCCTCCGGCTCTGTGG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5400763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4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AACCAAAGCGAAGCAAAAG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GGTCACCGCCGCAT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TGGCGACTCCCGACGACTG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0307014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MND8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TGCCAAGGCAGCGACA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CAGCTCCCGAAGCTCC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ACGACCACCCGTCTGCGG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18941954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HvPLA2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AGGACCACCGTGATGATCAG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CAGTGGTTGTCCAGCATG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ACATACCGAACAAGTACAGCCAGAAGCTGC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0411700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HvPLA3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GCGGAAGGACTCCAAGGA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GCGATCCCAGGGAAG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AGCATCTGCTGTACTCGCCACCG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6707863"/>
                  </a:ext>
                </a:extLst>
              </a:tr>
              <a:tr h="2899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ADP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ACAAGCTTGGCCTGCACTC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ACCAGATGTCGCGCAAGT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Yu Gothic" panose="020B0400000000000000" pitchFamily="34" charset="-128"/>
                        </a:rPr>
                        <a:t>CGCCAGCGGCACTGGTACATTCA</a:t>
                      </a: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69869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7062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1</TotalTime>
  <Words>42</Words>
  <Application>Microsoft Macintosh PowerPoint</Application>
  <PresentationFormat>A4 210 x 297 mm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Microsoft Office ユーザー</dc:creator>
  <cp:keywords/>
  <dc:description/>
  <cp:lastModifiedBy>Microsoft Office ユーザー</cp:lastModifiedBy>
  <cp:revision>179</cp:revision>
  <cp:lastPrinted>2019-06-06T02:25:27Z</cp:lastPrinted>
  <dcterms:created xsi:type="dcterms:W3CDTF">2019-05-23T03:32:55Z</dcterms:created>
  <dcterms:modified xsi:type="dcterms:W3CDTF">2021-04-14T08:33:41Z</dcterms:modified>
  <cp:category/>
</cp:coreProperties>
</file>